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846780-2DA1-474D-8EB7-A20526E8F2F9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CDACEA-9B64-4667-A5FE-49A447A48532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40E73-6368-4B50-84F4-86D62BBE9D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3C18F-6C39-4A64-8F59-BCDB8E4DE6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371D4-0876-4161-AFDD-C7F7842F37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A356A-1B02-4CB6-91DA-DFDF1132F5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2BB47-40A9-4288-BC02-4F663731FB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C43F1B-E65E-48DA-A77D-B228910578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9AEB5-155A-471A-9F7E-883A89EFB9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2D6BA-4144-4439-BECF-2021913F7A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8C3BEB-36A0-4048-B184-556E097FB9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3382B3-67D5-41D6-9C1F-2AAD5BD674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14611F-0B49-48B7-986B-D7EFED17AD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BCDAE3-F899-4A12-833B-AF28E3691D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7B6D60-AB89-47BA-A4D0-CDFCFCC8BA5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e 60"/>
          <p:cNvGrpSpPr/>
          <p:nvPr/>
        </p:nvGrpSpPr>
        <p:grpSpPr>
          <a:xfrm>
            <a:off x="3286080" y="1938240"/>
            <a:ext cx="3571920" cy="2428920"/>
            <a:chOff x="3286080" y="1938240"/>
            <a:chExt cx="3571920" cy="2428920"/>
          </a:xfrm>
        </p:grpSpPr>
        <p:grpSp>
          <p:nvGrpSpPr>
            <p:cNvPr id="49" name="Groupe 34"/>
            <p:cNvGrpSpPr/>
            <p:nvPr/>
          </p:nvGrpSpPr>
          <p:grpSpPr>
            <a:xfrm>
              <a:off x="5000760" y="1938240"/>
              <a:ext cx="1643040" cy="1500120"/>
              <a:chOff x="5000760" y="1938240"/>
              <a:chExt cx="1643040" cy="1500120"/>
            </a:xfrm>
          </p:grpSpPr>
          <p:sp>
            <p:nvSpPr>
              <p:cNvPr id="50" name="Rectangle 26"/>
              <p:cNvSpPr/>
              <p:nvPr/>
            </p:nvSpPr>
            <p:spPr>
              <a:xfrm rot="20904600">
                <a:off x="5187960" y="2013840"/>
                <a:ext cx="642960" cy="1224000"/>
              </a:xfrm>
              <a:prstGeom prst="rect">
                <a:avLst/>
              </a:prstGeom>
              <a:solidFill>
                <a:srgbClr val="c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ctangle 27"/>
              <p:cNvSpPr/>
              <p:nvPr/>
            </p:nvSpPr>
            <p:spPr>
              <a:xfrm rot="20540400">
                <a:off x="6021720" y="2031480"/>
                <a:ext cx="357120" cy="1235160"/>
              </a:xfrm>
              <a:prstGeom prst="rect">
                <a:avLst/>
              </a:prstGeom>
              <a:solidFill>
                <a:srgbClr val="c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32"/>
              <p:cNvSpPr/>
              <p:nvPr/>
            </p:nvSpPr>
            <p:spPr>
              <a:xfrm>
                <a:off x="5000760" y="1938240"/>
                <a:ext cx="1285920" cy="2142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33"/>
              <p:cNvSpPr/>
              <p:nvPr/>
            </p:nvSpPr>
            <p:spPr>
              <a:xfrm>
                <a:off x="5214960" y="3152880"/>
                <a:ext cx="1428840" cy="285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Rectangle 28"/>
            <p:cNvSpPr/>
            <p:nvPr/>
          </p:nvSpPr>
          <p:spPr>
            <a:xfrm rot="291000">
              <a:off x="3463200" y="3154320"/>
              <a:ext cx="1357200" cy="1066680"/>
            </a:xfrm>
            <a:prstGeom prst="rect">
              <a:avLst/>
            </a:prstGeom>
            <a:solidFill>
              <a:srgbClr val="c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43"/>
            <p:cNvSpPr/>
            <p:nvPr/>
          </p:nvSpPr>
          <p:spPr>
            <a:xfrm>
              <a:off x="3357360" y="4078440"/>
              <a:ext cx="1428840" cy="288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Connecteur droit 45"/>
            <p:cNvSpPr/>
            <p:nvPr/>
          </p:nvSpPr>
          <p:spPr>
            <a:xfrm>
              <a:off x="3428640" y="4081680"/>
              <a:ext cx="1836720" cy="0"/>
            </a:xfrm>
            <a:prstGeom prst="line">
              <a:avLst/>
            </a:prstGeom>
            <a:ln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lèche droite 46"/>
            <p:cNvSpPr/>
            <p:nvPr/>
          </p:nvSpPr>
          <p:spPr>
            <a:xfrm>
              <a:off x="3571560" y="3894120"/>
              <a:ext cx="357120" cy="357120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rgbClr val="4f81bd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Flèche droite 47"/>
            <p:cNvSpPr/>
            <p:nvPr/>
          </p:nvSpPr>
          <p:spPr>
            <a:xfrm>
              <a:off x="3929040" y="3894120"/>
              <a:ext cx="1214280" cy="357120"/>
            </a:xfrm>
            <a:prstGeom prst="rightArrow">
              <a:avLst>
                <a:gd name="adj1" fmla="val 100000"/>
                <a:gd name="adj2" fmla="val 49996"/>
              </a:avLst>
            </a:prstGeom>
            <a:solidFill>
              <a:srgbClr val="4f81bd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51"/>
            <p:cNvSpPr/>
            <p:nvPr/>
          </p:nvSpPr>
          <p:spPr>
            <a:xfrm>
              <a:off x="3286080" y="2938320"/>
              <a:ext cx="428400" cy="2174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52"/>
            <p:cNvSpPr/>
            <p:nvPr/>
          </p:nvSpPr>
          <p:spPr>
            <a:xfrm rot="21023400">
              <a:off x="3514680" y="2141280"/>
              <a:ext cx="72720" cy="1028520"/>
            </a:xfrm>
            <a:prstGeom prst="rect">
              <a:avLst/>
            </a:prstGeom>
            <a:solidFill>
              <a:srgbClr val="c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Connecteur droit 53"/>
            <p:cNvSpPr/>
            <p:nvPr/>
          </p:nvSpPr>
          <p:spPr>
            <a:xfrm>
              <a:off x="3357360" y="3152520"/>
              <a:ext cx="3203640" cy="0"/>
            </a:xfrm>
            <a:prstGeom prst="line">
              <a:avLst/>
            </a:prstGeom>
            <a:ln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lèche droite 54"/>
            <p:cNvSpPr/>
            <p:nvPr/>
          </p:nvSpPr>
          <p:spPr>
            <a:xfrm>
              <a:off x="4071960" y="2976480"/>
              <a:ext cx="1214280" cy="357120"/>
            </a:xfrm>
            <a:prstGeom prst="rightArrow">
              <a:avLst>
                <a:gd name="adj1" fmla="val 100000"/>
                <a:gd name="adj2" fmla="val 49996"/>
              </a:avLst>
            </a:prstGeom>
            <a:solidFill>
              <a:srgbClr val="4f81bd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lèche droite 55"/>
            <p:cNvSpPr/>
            <p:nvPr/>
          </p:nvSpPr>
          <p:spPr>
            <a:xfrm>
              <a:off x="3714480" y="2976480"/>
              <a:ext cx="357120" cy="357120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rgbClr val="4f81bd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Connecteur droit 57"/>
            <p:cNvSpPr/>
            <p:nvPr/>
          </p:nvSpPr>
          <p:spPr>
            <a:xfrm>
              <a:off x="3428640" y="2152440"/>
              <a:ext cx="3429360" cy="0"/>
            </a:xfrm>
            <a:prstGeom prst="line">
              <a:avLst/>
            </a:prstGeom>
            <a:ln w="38160">
              <a:solidFill>
                <a:srgbClr val="a6a6a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lèche droite 58"/>
            <p:cNvSpPr/>
            <p:nvPr/>
          </p:nvSpPr>
          <p:spPr>
            <a:xfrm>
              <a:off x="3857400" y="1976040"/>
              <a:ext cx="1214280" cy="357120"/>
            </a:xfrm>
            <a:prstGeom prst="rightArrow">
              <a:avLst>
                <a:gd name="adj1" fmla="val 100000"/>
                <a:gd name="adj2" fmla="val 49996"/>
              </a:avLst>
            </a:prstGeom>
            <a:solidFill>
              <a:srgbClr val="4f81bd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lèche droite 59"/>
            <p:cNvSpPr/>
            <p:nvPr/>
          </p:nvSpPr>
          <p:spPr>
            <a:xfrm>
              <a:off x="3500280" y="1976040"/>
              <a:ext cx="357120" cy="357120"/>
            </a:xfrm>
            <a:prstGeom prst="rightArrow">
              <a:avLst>
                <a:gd name="adj1" fmla="val 100000"/>
                <a:gd name="adj2" fmla="val 50000"/>
              </a:avLst>
            </a:prstGeom>
            <a:solidFill>
              <a:srgbClr val="4f81bd"/>
            </a:solidFill>
            <a:ln w="2556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ZoneTexte 61"/>
          <p:cNvSpPr/>
          <p:nvPr/>
        </p:nvSpPr>
        <p:spPr>
          <a:xfrm>
            <a:off x="1866960" y="2009880"/>
            <a:ext cx="12808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pMmc-9501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(1840 pb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ZoneTexte 62"/>
          <p:cNvSpPr/>
          <p:nvPr/>
        </p:nvSpPr>
        <p:spPr>
          <a:xfrm>
            <a:off x="1861920" y="2938320"/>
            <a:ext cx="9702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pADB20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(1717 pb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ZoneTexte 63"/>
          <p:cNvSpPr/>
          <p:nvPr/>
        </p:nvSpPr>
        <p:spPr>
          <a:xfrm>
            <a:off x="1861920" y="3925800"/>
            <a:ext cx="9702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pBG7AU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(1022 pb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ZoneTexte 65"/>
          <p:cNvSpPr/>
          <p:nvPr/>
        </p:nvSpPr>
        <p:spPr>
          <a:xfrm>
            <a:off x="4152960" y="1581120"/>
            <a:ext cx="534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600" spc="-1" strike="noStrike">
                <a:solidFill>
                  <a:srgbClr val="000000"/>
                </a:solidFill>
                <a:latin typeface="Calibri"/>
              </a:rPr>
              <a:t>orf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ZoneTexte 66"/>
          <p:cNvSpPr/>
          <p:nvPr/>
        </p:nvSpPr>
        <p:spPr>
          <a:xfrm>
            <a:off x="3360240" y="1581120"/>
            <a:ext cx="526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600" spc="-1" strike="noStrike">
                <a:solidFill>
                  <a:srgbClr val="000000"/>
                </a:solidFill>
                <a:latin typeface="Calibri"/>
              </a:rPr>
              <a:t>orf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095480" y="5300640"/>
            <a:ext cx="8048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egend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hree-way BLASTN comparison of three mycoplasma plasmid sequences using the Artemis Comparison Tool [68]. Red bars indicate regions of sequence homology (99% identity cutoff). This graphically illustrates the possible composite origin of plasmid pADB20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7T09:41:39Z</dcterms:created>
  <dc:creator>pdemol38</dc:creator>
  <dc:description/>
  <dc:language>en-US</dc:language>
  <cp:lastModifiedBy>THIAUCOURT</cp:lastModifiedBy>
  <dcterms:modified xsi:type="dcterms:W3CDTF">2011-02-02T10:04:18Z</dcterms:modified>
  <cp:revision>22</cp:revision>
  <dc:subject/>
  <dc:title>Diapositive 1</dc:title>
</cp:coreProperties>
</file>